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2" d="100"/>
          <a:sy n="82" d="100"/>
        </p:scale>
        <p:origin x="78" y="3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BB05DB-BBD7-4C23-742A-AE7FB5ED06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52B21C0-04A7-BF50-4C33-515898060B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54A972-35BE-C5E2-AC3E-A04C4761B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F7A02A-6302-FFB0-6E1D-DEC7CE95E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A4F73A-2478-F7ED-E72A-11A45D97D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030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CC9FC5-AF60-D041-FF10-8C68B5B00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C1F48F-637C-7114-7CD5-BBB9ECD19A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284698-C52F-D934-720B-595D6E3DB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6EB917-BEC8-3DBF-ABFD-1CDA92926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CEBC70-E170-F9D7-B59B-FEF3AC898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257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1FF909B-7988-85DD-F58C-B112E6347D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4DCF5D0-CB6D-DBED-A175-29E2EF45DC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B9EE4D-72D8-AA59-D7CD-E27A5F534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D23098-2A16-6A40-9A83-EDBFC4EB6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EB7693-70AF-E697-7B2D-E5A668DD6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110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80568-6137-DF88-9E06-D89D5860D5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D58AF0-292A-7FDD-931F-84CDB62B0C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7E644E-DA29-8B06-21CF-495128E01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E3B9B9-F093-C1D2-26B9-62A249AC6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876BFE-ED94-A1CD-50FA-B963C2C15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87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FEC499-25FD-1D3A-6BE6-1E1A4841D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2F5A715-E130-B195-3FA9-FF507D3203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35FD44-B528-9155-71BF-849BECF12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C28C56-AB38-612A-E7ED-92236F65B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A91C0D-8F7D-04C9-3971-834F9D118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6993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B1DD53-85A0-9A08-E895-679B7DE20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A9B0F2F-9A17-AE21-6560-EC0B7E1E6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E84030C-956B-F36F-4C1B-8AB76590B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E5D365-82C9-1C54-D138-749F65645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D6B9A3-F230-A84B-6059-9E486D568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7ACA22B-BFE6-4C7D-5C56-1724415CA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155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BCBC93-3476-0C15-469D-18EBEB0686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031A97-272A-6AEB-7F0C-C5016D6A39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CC51B1-8690-C7A0-5AA0-405B5764EA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49604D-1D65-865F-B95B-ADED8FFD23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75D7BBC-2361-4650-8337-EE97EAE257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D5BD0EF-7978-AC03-5F2F-571CAE6B6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4DD519-FD3F-991F-1B01-4B21237A1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7DAA1CD-60F2-BE3E-AF16-90E17B72E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7814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3C1E77-F4CA-6743-73AC-F205F8C709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ADF54E8-5BA3-04F2-259D-989ED6B7E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BD84163-4DA2-E9A4-B571-F78282B35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E86E6A8-E66F-90C7-B9A8-6C30A0F21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398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35228F1-708E-1784-2CD2-C21BF8DC1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0DE1A9-1A89-B596-E640-1826BF93A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250FA7E-DFDE-5607-3381-13598E895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416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2496E1-74A5-1B20-A470-07E81C7D4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85C5EA-C543-15F3-EEB4-C4791909A3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3C4E32-37D6-B948-1189-14B73753DC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D5A5708-F2B9-13C7-1CA2-36331401C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54CFFD-47A1-D616-E9B9-6F20E0B22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43BD87-F806-3F22-F75C-FB041F52C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4141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53D419-D912-EABF-E460-5B0A5D07E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3A6FABF-2244-F4C9-0FE0-2EE906FBF6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B6F477C-FCA5-F25D-A141-88F07BE669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B419DC-2A31-6298-1E24-E16FCFD9F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2D925C-E635-1811-2E3E-493E2B534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49D866E-42BB-5FDE-A9BD-653CFAD8B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461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ACCCA14-17CC-1701-D2D6-E2EB684FAC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09458D6-F7C5-0AB1-D233-E7D725753A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A674B0-B247-2412-918B-0EF0190935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EF089-0EC4-4495-85BA-154644393038}" type="datetimeFigureOut">
              <a:rPr kumimoji="1" lang="ja-JP" altLang="en-US" smtClean="0"/>
              <a:t>2022/8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372FAA-429B-FEDF-CDEA-1919E7802B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6F4C7B-B7FB-A40F-5ACF-ADBA89023E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D89357-3DC1-44D0-BE89-713471CBBE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306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65EB998-EF7F-1CDE-2AC5-9D30E0EB16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3080" y="20320"/>
            <a:ext cx="6085840" cy="608584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00C7603-CE10-E5BD-AEF1-CDA9EE4E2315}"/>
              </a:ext>
            </a:extLst>
          </p:cNvPr>
          <p:cNvSpPr txBox="1"/>
          <p:nvPr/>
        </p:nvSpPr>
        <p:spPr>
          <a:xfrm>
            <a:off x="0" y="6211669"/>
            <a:ext cx="122623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Supplementary Figure 1: Receiver operating characteristic </a:t>
            </a:r>
            <a:r>
              <a:rPr lang="en-US" altLang="ja-JP" dirty="0"/>
              <a:t>curve for the predictive value of adverse </a:t>
            </a:r>
            <a:r>
              <a:rPr lang="en-US" altLang="ja-JP"/>
              <a:t>pathological findings </a:t>
            </a:r>
            <a:r>
              <a:rPr lang="en-US" altLang="ja-JP" dirty="0"/>
              <a:t>by </a:t>
            </a:r>
            <a:r>
              <a:rPr kumimoji="1" lang="en-US" altLang="ja-JP" dirty="0"/>
              <a:t>the highest percentage of Gleason pattern 4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77989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4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 Shun</dc:creator>
  <cp:lastModifiedBy>Sato Shun</cp:lastModifiedBy>
  <cp:revision>4</cp:revision>
  <dcterms:created xsi:type="dcterms:W3CDTF">2022-05-23T04:55:25Z</dcterms:created>
  <dcterms:modified xsi:type="dcterms:W3CDTF">2022-08-27T08:07:34Z</dcterms:modified>
</cp:coreProperties>
</file>